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74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682EA9-3914-4040-9027-9C14CE2647A2}" type="datetimeFigureOut">
              <a:rPr lang="zh-CN" altLang="en-US" smtClean="0"/>
              <a:t>2021/6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8A106-20FF-4862-8D00-E7D7C56260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178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682EA9-3914-4040-9027-9C14CE2647A2}" type="datetimeFigureOut">
              <a:rPr lang="zh-CN" altLang="en-US" smtClean="0"/>
              <a:t>2021/6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8A106-20FF-4862-8D00-E7D7C56260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4897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682EA9-3914-4040-9027-9C14CE2647A2}" type="datetimeFigureOut">
              <a:rPr lang="zh-CN" altLang="en-US" smtClean="0"/>
              <a:t>2021/6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8A106-20FF-4862-8D00-E7D7C56260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92709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682EA9-3914-4040-9027-9C14CE2647A2}" type="datetimeFigureOut">
              <a:rPr lang="zh-CN" altLang="en-US" smtClean="0"/>
              <a:t>2021/6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8A106-20FF-4862-8D00-E7D7C56260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0097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682EA9-3914-4040-9027-9C14CE2647A2}" type="datetimeFigureOut">
              <a:rPr lang="zh-CN" altLang="en-US" smtClean="0"/>
              <a:t>2021/6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8A106-20FF-4862-8D00-E7D7C56260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79074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682EA9-3914-4040-9027-9C14CE2647A2}" type="datetimeFigureOut">
              <a:rPr lang="zh-CN" altLang="en-US" smtClean="0"/>
              <a:t>2021/6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8A106-20FF-4862-8D00-E7D7C56260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7419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682EA9-3914-4040-9027-9C14CE2647A2}" type="datetimeFigureOut">
              <a:rPr lang="zh-CN" altLang="en-US" smtClean="0"/>
              <a:t>2021/6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8A106-20FF-4862-8D00-E7D7C56260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1716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682EA9-3914-4040-9027-9C14CE2647A2}" type="datetimeFigureOut">
              <a:rPr lang="zh-CN" altLang="en-US" smtClean="0"/>
              <a:t>2021/6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8A106-20FF-4862-8D00-E7D7C56260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94381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682EA9-3914-4040-9027-9C14CE2647A2}" type="datetimeFigureOut">
              <a:rPr lang="zh-CN" altLang="en-US" smtClean="0"/>
              <a:t>2021/6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8A106-20FF-4862-8D00-E7D7C56260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2091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682EA9-3914-4040-9027-9C14CE2647A2}" type="datetimeFigureOut">
              <a:rPr lang="zh-CN" altLang="en-US" smtClean="0"/>
              <a:t>2021/6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8A106-20FF-4862-8D00-E7D7C56260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7920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682EA9-3914-4040-9027-9C14CE2647A2}" type="datetimeFigureOut">
              <a:rPr lang="zh-CN" altLang="en-US" smtClean="0"/>
              <a:t>2021/6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8A106-20FF-4862-8D00-E7D7C56260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42424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682EA9-3914-4040-9027-9C14CE2647A2}" type="datetimeFigureOut">
              <a:rPr lang="zh-CN" altLang="en-US" smtClean="0"/>
              <a:t>2021/6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98A106-20FF-4862-8D00-E7D7C56260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5106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直接连接符 7"/>
          <p:cNvCxnSpPr>
            <a:stCxn id="35" idx="2"/>
            <a:endCxn id="58" idx="0"/>
          </p:cNvCxnSpPr>
          <p:nvPr/>
        </p:nvCxnSpPr>
        <p:spPr>
          <a:xfrm>
            <a:off x="6216116" y="4880816"/>
            <a:ext cx="0" cy="597876"/>
          </a:xfrm>
          <a:prstGeom prst="line">
            <a:avLst/>
          </a:prstGeom>
          <a:ln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矩形 8"/>
          <p:cNvSpPr/>
          <p:nvPr/>
        </p:nvSpPr>
        <p:spPr>
          <a:xfrm>
            <a:off x="4366883" y="253211"/>
            <a:ext cx="3692817" cy="587094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rolled </a:t>
            </a:r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cally advanced LUAD patients with recurrence (N </a:t>
            </a:r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6)</a:t>
            </a:r>
            <a:endParaRPr lang="zh-CN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接连接符 14"/>
          <p:cNvCxnSpPr/>
          <p:nvPr/>
        </p:nvCxnSpPr>
        <p:spPr>
          <a:xfrm flipH="1">
            <a:off x="7949334" y="3205431"/>
            <a:ext cx="2" cy="13699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 flipH="1">
            <a:off x="6213291" y="825976"/>
            <a:ext cx="2702" cy="183839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接连接符 22"/>
          <p:cNvCxnSpPr>
            <a:stCxn id="13" idx="2"/>
            <a:endCxn id="35" idx="0"/>
          </p:cNvCxnSpPr>
          <p:nvPr/>
        </p:nvCxnSpPr>
        <p:spPr>
          <a:xfrm>
            <a:off x="3365844" y="3605270"/>
            <a:ext cx="2850272" cy="68249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矩形 9"/>
          <p:cNvSpPr/>
          <p:nvPr/>
        </p:nvSpPr>
        <p:spPr>
          <a:xfrm>
            <a:off x="4366883" y="1136381"/>
            <a:ext cx="3692817" cy="587094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FPE samples of matched primary tumor and lymph node metastases</a:t>
            </a:r>
            <a:endParaRPr lang="zh-CN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接连接符 27"/>
          <p:cNvCxnSpPr/>
          <p:nvPr/>
        </p:nvCxnSpPr>
        <p:spPr>
          <a:xfrm>
            <a:off x="6213291" y="2128379"/>
            <a:ext cx="961444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矩形 28"/>
          <p:cNvSpPr/>
          <p:nvPr/>
        </p:nvSpPr>
        <p:spPr>
          <a:xfrm>
            <a:off x="7130293" y="1912352"/>
            <a:ext cx="2723155" cy="432053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A extraction and RNA IO profiling</a:t>
            </a:r>
          </a:p>
          <a:p>
            <a:pPr algn="ctr"/>
            <a:r>
              <a:rPr lang="en-US" altLang="zh-CN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cluded 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US" altLang="zh-CN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C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接连接符 31"/>
          <p:cNvCxnSpPr/>
          <p:nvPr/>
        </p:nvCxnSpPr>
        <p:spPr>
          <a:xfrm>
            <a:off x="3365843" y="2664372"/>
            <a:ext cx="57308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>
            <a:endCxn id="54" idx="0"/>
          </p:cNvCxnSpPr>
          <p:nvPr/>
        </p:nvCxnSpPr>
        <p:spPr>
          <a:xfrm>
            <a:off x="9082157" y="2683921"/>
            <a:ext cx="1" cy="2797445"/>
          </a:xfrm>
          <a:prstGeom prst="line">
            <a:avLst/>
          </a:prstGeom>
          <a:ln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矩形 32"/>
          <p:cNvSpPr/>
          <p:nvPr/>
        </p:nvSpPr>
        <p:spPr>
          <a:xfrm>
            <a:off x="7949334" y="3007249"/>
            <a:ext cx="2265649" cy="59304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mph node metastases</a:t>
            </a:r>
          </a:p>
          <a:p>
            <a:pPr algn="ctr"/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 (N = </a:t>
            </a:r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), </a:t>
            </a:r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R (N = </a:t>
            </a:r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)</a:t>
            </a:r>
            <a:endParaRPr lang="en-US" altLang="zh-CN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/>
          <p:cNvSpPr/>
          <p:nvPr/>
        </p:nvSpPr>
        <p:spPr>
          <a:xfrm>
            <a:off x="5083291" y="4287769"/>
            <a:ext cx="2265649" cy="59304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tched pair</a:t>
            </a:r>
          </a:p>
          <a:p>
            <a:pPr algn="ctr"/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 </a:t>
            </a:r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 = </a:t>
            </a:r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), LR </a:t>
            </a:r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 = </a:t>
            </a:r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)</a:t>
            </a:r>
            <a:endParaRPr lang="en-US" altLang="zh-CN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/>
          <p:cNvCxnSpPr>
            <a:stCxn id="33" idx="2"/>
            <a:endCxn id="35" idx="0"/>
          </p:cNvCxnSpPr>
          <p:nvPr/>
        </p:nvCxnSpPr>
        <p:spPr>
          <a:xfrm flipH="1">
            <a:off x="6216116" y="3600296"/>
            <a:ext cx="2866043" cy="68747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矩形 53"/>
          <p:cNvSpPr/>
          <p:nvPr/>
        </p:nvSpPr>
        <p:spPr>
          <a:xfrm>
            <a:off x="7949333" y="5481366"/>
            <a:ext cx="2265649" cy="820504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ially expressed immunological </a:t>
            </a:r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hways and </a:t>
            </a:r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Ls</a:t>
            </a:r>
            <a:endParaRPr lang="en-US" altLang="zh-CN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直接连接符 56"/>
          <p:cNvCxnSpPr>
            <a:endCxn id="53" idx="0"/>
          </p:cNvCxnSpPr>
          <p:nvPr/>
        </p:nvCxnSpPr>
        <p:spPr>
          <a:xfrm flipH="1">
            <a:off x="3350074" y="2656730"/>
            <a:ext cx="2" cy="2821962"/>
          </a:xfrm>
          <a:prstGeom prst="line">
            <a:avLst/>
          </a:prstGeom>
          <a:ln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矩形 52"/>
          <p:cNvSpPr/>
          <p:nvPr/>
        </p:nvSpPr>
        <p:spPr>
          <a:xfrm>
            <a:off x="2217249" y="5478692"/>
            <a:ext cx="2265649" cy="820504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ially expressed immunological </a:t>
            </a:r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hways and </a:t>
            </a:r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Ls</a:t>
            </a:r>
            <a:endParaRPr lang="en-US" altLang="zh-CN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矩形 57"/>
          <p:cNvSpPr/>
          <p:nvPr/>
        </p:nvSpPr>
        <p:spPr>
          <a:xfrm>
            <a:off x="5083291" y="5478692"/>
            <a:ext cx="2265649" cy="820504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red immune factors</a:t>
            </a:r>
            <a:endParaRPr lang="en-US" altLang="zh-CN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2233019" y="3012223"/>
            <a:ext cx="2265649" cy="59304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 lung cancer</a:t>
            </a:r>
          </a:p>
          <a:p>
            <a:pPr algn="ctr"/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 </a:t>
            </a:r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 = </a:t>
            </a:r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), LR </a:t>
            </a:r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 = </a:t>
            </a:r>
            <a:r>
              <a:rPr lang="en-US" altLang="zh-CN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)</a:t>
            </a:r>
            <a:endParaRPr lang="en-US" altLang="zh-CN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直接连接符 73"/>
          <p:cNvCxnSpPr>
            <a:stCxn id="53" idx="3"/>
            <a:endCxn id="58" idx="1"/>
          </p:cNvCxnSpPr>
          <p:nvPr/>
        </p:nvCxnSpPr>
        <p:spPr>
          <a:xfrm>
            <a:off x="4482898" y="5888944"/>
            <a:ext cx="600393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接连接符 74"/>
          <p:cNvCxnSpPr/>
          <p:nvPr/>
        </p:nvCxnSpPr>
        <p:spPr>
          <a:xfrm>
            <a:off x="7348940" y="5864427"/>
            <a:ext cx="600393" cy="0"/>
          </a:xfrm>
          <a:prstGeom prst="line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矩形 77"/>
          <p:cNvSpPr/>
          <p:nvPr/>
        </p:nvSpPr>
        <p:spPr>
          <a:xfrm>
            <a:off x="123834" y="6457474"/>
            <a:ext cx="1111758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zh-CN" sz="1400" b="1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Figure S1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iagram for 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UAD patients included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altLang="zh-CN" sz="1400" b="1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RNA IO profiling analysis. 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0620384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</Words>
  <Application>Microsoft Office PowerPoint</Application>
  <PresentationFormat>宽屏</PresentationFormat>
  <Paragraphs>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微软雅黑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1</cp:revision>
  <dcterms:created xsi:type="dcterms:W3CDTF">2021-06-21T07:14:20Z</dcterms:created>
  <dcterms:modified xsi:type="dcterms:W3CDTF">2021-06-21T07:15:58Z</dcterms:modified>
</cp:coreProperties>
</file>